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00"/>
    <a:srgbClr val="6600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9" autoAdjust="0"/>
    <p:restoredTop sz="94660"/>
  </p:normalViewPr>
  <p:slideViewPr>
    <p:cSldViewPr snapToGrid="0">
      <p:cViewPr varScale="1">
        <p:scale>
          <a:sx n="88" d="100"/>
          <a:sy n="88" d="100"/>
        </p:scale>
        <p:origin x="60" y="11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32A087-610C-4A2D-BFEA-E6066072FA9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36A305-A877-46CB-B3A9-E825BD77DC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2749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36A305-A877-46CB-B3A9-E825BD77DC9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791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93D687-7917-AF96-2083-BE5DD69C6B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0AF580E-271C-8573-A3AA-4322C5765A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7BC2A9-1C8D-DDB1-AB7F-E52517630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4D75D6-E805-9CF8-A5F1-0DDD97D73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149A2D-2565-4DA1-E34A-3AC918FB2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636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44FA41-7EFE-6CAE-D360-A80A551A54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3220CC2-E885-8272-61F0-F9F1F656D7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EB22F4-F981-E8C9-4BA6-3AEECA3AA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780BB2-32C1-5B04-739B-D23591A7F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A7D371-A86D-4C9F-D31D-B2F1559E4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744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1A7970E-AA44-1220-F769-6638911B88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28A34B9-CA3F-55BD-41AF-2C33927B0D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CFFA9D-EA35-12BA-6663-ACB7CBF7A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5CE27D-48F2-926E-8040-12A43D0D5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E07559-6E9F-25A2-A47A-DABDAB16A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136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7A45D0-D37A-BB53-3B0C-AF4E38B3D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D9B368A-2498-49E1-645B-C20F1B3191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D663C3-9C20-BE3B-25A6-E162F19CE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58F056-DA08-3D99-648D-4EDA929DE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ACA2E3-97EE-016D-743E-E81B67BFA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473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3181D5-C4A7-38C5-319E-1E572617E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89D4C25-2B17-4F77-84EA-A20A157E0E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FEB64D-19F5-08BE-EAEF-87DF709C1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07549D-ABA3-EB08-8290-44E3B04E8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CBED87E-53CF-DEF2-DCD3-80E2DE3CF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893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9E8176-966B-00DC-47EF-80D1A9F53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8F2C4EF-7CF5-65C5-ECA5-79D17119B7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2CC36BA-FB16-683C-862E-29F5F70829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A3D69E1-81B7-BDFA-471C-A237BE47D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872E425-3DF6-E4E1-CF4F-01D76A2AA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2490298-196B-F248-42A0-31A06A7C9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958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15912B-9EB8-A6D9-430A-074890A91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7711D1-44E9-ACD2-996B-FEAACEDB2E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574325-69CA-AC0A-B752-311A35A39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0B8EB0C-0AEE-1577-72A6-FD080455F1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231AAA8-FD7D-BCDD-16B4-24F9F37929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11E3ABF-20BD-CD53-ED40-F4E92255C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EF2AC9D-B694-C637-4096-383B889E3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287BCBB-6053-DAF6-2F9C-133E49C16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098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E92910-1DEB-DF57-99D2-269E69BDB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C3186B7-007E-5664-5002-BA742C6A3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1975313-6A14-36F6-2637-CAEE52EAB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C795A2A-0464-7A95-F016-018C8C07F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0190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D31F1F0-3983-57BD-2019-A9FA64A92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CA3F45-BFDC-C997-7C5F-096D07C4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47D842F-D802-6E74-102E-932E2489F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944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DA8639-4CCA-D974-9CD5-B707C245A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614FE5A-DEAD-053C-5C0D-D5AD817772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7B511F-8209-5F5B-BE99-5C037D5F4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83B58B4-4BCC-BE4B-BAF5-28152A33A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C01102-C8F0-117D-8D40-A7D3AFBC4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DED17E-2CD0-AE71-99A0-C44091ACE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383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334AEB-83A9-33DF-0078-3ADFF9CE3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20EE52E-E90B-561A-0BD6-932FBEF63F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41153CF-B0F9-6EDE-3D79-D827745D7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D5CB949-6EB0-0C73-598D-0BF1D14B6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106B57-279C-DC9B-138A-79C275570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11062D-AC7B-41E2-BA17-62C67C80C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025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3EF9513-5A52-1EE3-9387-48A0DBF13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2F3A20-4EBC-4306-0981-7A43D4C29A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7C7209-ACFD-1433-A499-8D0198D20A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89A36-B8B9-4551-861A-5DD988DED30A}" type="datetimeFigureOut">
              <a:rPr kumimoji="1" lang="ja-JP" altLang="en-US" smtClean="0"/>
              <a:t>2025/4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B22CF8-3547-B503-50A9-AF94430923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EBC64B-F869-48AF-3263-860E06C47C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D4C05-CB4E-40A8-AD72-CC81274E9F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89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74336E-C684-F49B-5DA2-9FBBB98888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E4F692DE-243D-7402-79CE-7A422F1F15FA}"/>
              </a:ext>
            </a:extLst>
          </p:cNvPr>
          <p:cNvSpPr txBox="1"/>
          <p:nvPr/>
        </p:nvSpPr>
        <p:spPr>
          <a:xfrm>
            <a:off x="0" y="5513390"/>
            <a:ext cx="12192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  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plan-Meier curves for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 free survival (PFS)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The median PFS in the plus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lymphocyte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plus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lympho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solid line) was significantly better than that in 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minus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lymphocyte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</a:t>
            </a:r>
            <a:r>
              <a:rPr lang="en-US" altLang="ja-JP" sz="16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inus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lympho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dotted line).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5" name="グループ化 4"/>
          <p:cNvGrpSpPr/>
          <p:nvPr/>
        </p:nvGrpSpPr>
        <p:grpSpPr>
          <a:xfrm>
            <a:off x="144881" y="607313"/>
            <a:ext cx="5864722" cy="4813346"/>
            <a:chOff x="144881" y="607313"/>
            <a:chExt cx="5864722" cy="4813346"/>
          </a:xfrm>
        </p:grpSpPr>
        <p:sp>
          <p:nvSpPr>
            <p:cNvPr id="148" name="Line 8">
              <a:extLst>
                <a:ext uri="{FF2B5EF4-FFF2-40B4-BE49-F238E27FC236}">
                  <a16:creationId xmlns:a16="http://schemas.microsoft.com/office/drawing/2014/main" id="{ED754B23-8129-CEB3-FA84-77E29D21283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94599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Line 9">
              <a:extLst>
                <a:ext uri="{FF2B5EF4-FFF2-40B4-BE49-F238E27FC236}">
                  <a16:creationId xmlns:a16="http://schemas.microsoft.com/office/drawing/2014/main" id="{BCDED379-8575-9832-7364-E8CC468CE4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41954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Line 10">
              <a:extLst>
                <a:ext uri="{FF2B5EF4-FFF2-40B4-BE49-F238E27FC236}">
                  <a16:creationId xmlns:a16="http://schemas.microsoft.com/office/drawing/2014/main" id="{07D51B74-6B7F-0317-93A0-A94B255834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89308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Line 11">
              <a:extLst>
                <a:ext uri="{FF2B5EF4-FFF2-40B4-BE49-F238E27FC236}">
                  <a16:creationId xmlns:a16="http://schemas.microsoft.com/office/drawing/2014/main" id="{9ED6315B-F918-E918-624B-48FE41D196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36663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Line 12">
              <a:extLst>
                <a:ext uri="{FF2B5EF4-FFF2-40B4-BE49-F238E27FC236}">
                  <a16:creationId xmlns:a16="http://schemas.microsoft.com/office/drawing/2014/main" id="{97AC9A5B-7014-FB5E-6E1B-0C594653EB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84017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Line 13">
              <a:extLst>
                <a:ext uri="{FF2B5EF4-FFF2-40B4-BE49-F238E27FC236}">
                  <a16:creationId xmlns:a16="http://schemas.microsoft.com/office/drawing/2014/main" id="{1988CC84-27B3-8769-F352-1CF66F68C3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1371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Line 14">
              <a:extLst>
                <a:ext uri="{FF2B5EF4-FFF2-40B4-BE49-F238E27FC236}">
                  <a16:creationId xmlns:a16="http://schemas.microsoft.com/office/drawing/2014/main" id="{C395702D-83A8-7E6A-C1B5-687938D990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78725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Line 15">
              <a:extLst>
                <a:ext uri="{FF2B5EF4-FFF2-40B4-BE49-F238E27FC236}">
                  <a16:creationId xmlns:a16="http://schemas.microsoft.com/office/drawing/2014/main" id="{A100CC58-9740-FAF1-E261-BB6B259624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097" y="4185991"/>
              <a:ext cx="947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Line 16">
              <a:extLst>
                <a:ext uri="{FF2B5EF4-FFF2-40B4-BE49-F238E27FC236}">
                  <a16:creationId xmlns:a16="http://schemas.microsoft.com/office/drawing/2014/main" id="{BE3D2FD0-7E8C-30AA-019F-F2A11EE776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097" y="3533618"/>
              <a:ext cx="947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Line 17">
              <a:extLst>
                <a:ext uri="{FF2B5EF4-FFF2-40B4-BE49-F238E27FC236}">
                  <a16:creationId xmlns:a16="http://schemas.microsoft.com/office/drawing/2014/main" id="{4186EBB0-816A-450A-CCA9-F8FCA5895C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097" y="2879813"/>
              <a:ext cx="947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Line 18">
              <a:extLst>
                <a:ext uri="{FF2B5EF4-FFF2-40B4-BE49-F238E27FC236}">
                  <a16:creationId xmlns:a16="http://schemas.microsoft.com/office/drawing/2014/main" id="{6A85CA3E-5992-E865-4FCF-E50AAA2CAE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097" y="2227442"/>
              <a:ext cx="947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Line 19">
              <a:extLst>
                <a:ext uri="{FF2B5EF4-FFF2-40B4-BE49-F238E27FC236}">
                  <a16:creationId xmlns:a16="http://schemas.microsoft.com/office/drawing/2014/main" id="{CF76C706-7BBD-F664-892C-E1819BA275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097" y="1575070"/>
              <a:ext cx="947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Line 20">
              <a:extLst>
                <a:ext uri="{FF2B5EF4-FFF2-40B4-BE49-F238E27FC236}">
                  <a16:creationId xmlns:a16="http://schemas.microsoft.com/office/drawing/2014/main" id="{EA788653-3BFF-6516-7282-4B818FFDE5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097" y="922698"/>
              <a:ext cx="94763" cy="0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Line 21">
              <a:extLst>
                <a:ext uri="{FF2B5EF4-FFF2-40B4-BE49-F238E27FC236}">
                  <a16:creationId xmlns:a16="http://schemas.microsoft.com/office/drawing/2014/main" id="{5481CB6B-5345-1BC9-6ACE-1E70AB000B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097" y="4368082"/>
              <a:ext cx="4982506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ectangle 24">
              <a:extLst>
                <a:ext uri="{FF2B5EF4-FFF2-40B4-BE49-F238E27FC236}">
                  <a16:creationId xmlns:a16="http://schemas.microsoft.com/office/drawing/2014/main" id="{88255DB7-95DE-5010-90FA-65EFE88368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9385" y="4411074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12</a:t>
              </a:r>
              <a:endParaRPr kumimoji="1" lang="ja-JP" altLang="ja-JP" sz="2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25">
              <a:extLst>
                <a:ext uri="{FF2B5EF4-FFF2-40B4-BE49-F238E27FC236}">
                  <a16:creationId xmlns:a16="http://schemas.microsoft.com/office/drawing/2014/main" id="{82F5BD1A-2FD1-25A1-895A-C96D81153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3990" y="4411074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1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4" name="Rectangle 26">
              <a:extLst>
                <a:ext uri="{FF2B5EF4-FFF2-40B4-BE49-F238E27FC236}">
                  <a16:creationId xmlns:a16="http://schemas.microsoft.com/office/drawing/2014/main" id="{C41748CE-D9B5-2A48-2A10-F47D0B3B5E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1548" y="4411074"/>
              <a:ext cx="67618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8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27">
              <a:extLst>
                <a:ext uri="{FF2B5EF4-FFF2-40B4-BE49-F238E27FC236}">
                  <a16:creationId xmlns:a16="http://schemas.microsoft.com/office/drawing/2014/main" id="{29D25088-A8E8-7052-2CA8-C3563959C7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3901" y="4411074"/>
              <a:ext cx="67618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6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6" name="Rectangle 28">
              <a:extLst>
                <a:ext uri="{FF2B5EF4-FFF2-40B4-BE49-F238E27FC236}">
                  <a16:creationId xmlns:a16="http://schemas.microsoft.com/office/drawing/2014/main" id="{57D63F9C-BA8D-BF47-C5FA-31CB11FE86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3303" y="4411074"/>
              <a:ext cx="67618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4</a:t>
              </a:r>
              <a:endParaRPr kumimoji="1" lang="ja-JP" altLang="ja-JP" sz="2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7" name="Rectangle 29">
              <a:extLst>
                <a:ext uri="{FF2B5EF4-FFF2-40B4-BE49-F238E27FC236}">
                  <a16:creationId xmlns:a16="http://schemas.microsoft.com/office/drawing/2014/main" id="{7E9BA1EC-DCEA-2565-CBC3-8601ED83FD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6532" y="4411074"/>
              <a:ext cx="67618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2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8" name="Rectangle 30">
              <a:extLst>
                <a:ext uri="{FF2B5EF4-FFF2-40B4-BE49-F238E27FC236}">
                  <a16:creationId xmlns:a16="http://schemas.microsoft.com/office/drawing/2014/main" id="{218EE0F4-8ADB-6C89-4B1F-C150297F29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4717" y="4411074"/>
              <a:ext cx="67618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69" name="Line 31">
              <a:extLst>
                <a:ext uri="{FF2B5EF4-FFF2-40B4-BE49-F238E27FC236}">
                  <a16:creationId xmlns:a16="http://schemas.microsoft.com/office/drawing/2014/main" id="{D163680A-6F91-2B1B-21FD-ED0AEF12EF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097" y="750131"/>
              <a:ext cx="0" cy="3627476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Rectangle 36">
              <a:extLst>
                <a:ext uri="{FF2B5EF4-FFF2-40B4-BE49-F238E27FC236}">
                  <a16:creationId xmlns:a16="http://schemas.microsoft.com/office/drawing/2014/main" id="{3B09D6A6-7887-BCD6-BF4C-387A30AC81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254" y="832093"/>
              <a:ext cx="202853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10</a:t>
              </a: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71" name="Rectangle 37">
              <a:extLst>
                <a:ext uri="{FF2B5EF4-FFF2-40B4-BE49-F238E27FC236}">
                  <a16:creationId xmlns:a16="http://schemas.microsoft.com/office/drawing/2014/main" id="{34BB3306-D682-C2F9-FDE3-BC77797ACC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6614" y="1487948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8</a:t>
              </a: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72" name="Rectangle 38">
              <a:extLst>
                <a:ext uri="{FF2B5EF4-FFF2-40B4-BE49-F238E27FC236}">
                  <a16:creationId xmlns:a16="http://schemas.microsoft.com/office/drawing/2014/main" id="{F0988182-DF12-7FEE-272F-CAED538764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6614" y="2142881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6</a:t>
              </a: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73" name="Rectangle 39">
              <a:extLst>
                <a:ext uri="{FF2B5EF4-FFF2-40B4-BE49-F238E27FC236}">
                  <a16:creationId xmlns:a16="http://schemas.microsoft.com/office/drawing/2014/main" id="{39D14027-2B0E-D838-B403-FFB55744D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6614" y="2789210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4</a:t>
              </a: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74" name="Rectangle 40">
              <a:extLst>
                <a:ext uri="{FF2B5EF4-FFF2-40B4-BE49-F238E27FC236}">
                  <a16:creationId xmlns:a16="http://schemas.microsoft.com/office/drawing/2014/main" id="{04CF714D-CF70-C75E-547C-3FF9101289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6614" y="3445063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2</a:t>
              </a: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75" name="Rectangle 41">
              <a:extLst>
                <a:ext uri="{FF2B5EF4-FFF2-40B4-BE49-F238E27FC236}">
                  <a16:creationId xmlns:a16="http://schemas.microsoft.com/office/drawing/2014/main" id="{DC61F223-5D60-2FEE-F9B6-D87ABC0884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3972" y="4096822"/>
              <a:ext cx="67618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0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EF5F95EF-6784-0E90-9828-9AD6115FB5B8}"/>
                </a:ext>
              </a:extLst>
            </p:cNvPr>
            <p:cNvSpPr txBox="1"/>
            <p:nvPr/>
          </p:nvSpPr>
          <p:spPr>
            <a:xfrm rot="16200000">
              <a:off x="76522" y="2397946"/>
              <a:ext cx="8451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PF</a:t>
              </a:r>
              <a:r>
                <a:rPr kumimoji="1" lang="en-US" altLang="ja-JP" sz="14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S (%)</a:t>
              </a:r>
              <a:endParaRPr kumimoji="1" lang="ja-JP" altLang="en-US" sz="14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83F31ADA-333E-8C8F-B441-17D75E75D1F9}"/>
                </a:ext>
              </a:extLst>
            </p:cNvPr>
            <p:cNvSpPr txBox="1"/>
            <p:nvPr/>
          </p:nvSpPr>
          <p:spPr>
            <a:xfrm>
              <a:off x="1014385" y="4742242"/>
              <a:ext cx="1045934" cy="249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Number at risk</a:t>
              </a:r>
              <a:endParaRPr kumimoji="1" lang="ja-JP" altLang="en-US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79" name="Rectangle 26">
              <a:extLst>
                <a:ext uri="{FF2B5EF4-FFF2-40B4-BE49-F238E27FC236}">
                  <a16:creationId xmlns:a16="http://schemas.microsoft.com/office/drawing/2014/main" id="{2393D046-F778-5508-BC57-027C646114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731" y="5012199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7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0" name="Rectangle 26">
              <a:extLst>
                <a:ext uri="{FF2B5EF4-FFF2-40B4-BE49-F238E27FC236}">
                  <a16:creationId xmlns:a16="http://schemas.microsoft.com/office/drawing/2014/main" id="{6D63CCB2-B91B-427B-3E90-B4BB1DED31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4022" y="5012199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3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1" name="Rectangle 26">
              <a:extLst>
                <a:ext uri="{FF2B5EF4-FFF2-40B4-BE49-F238E27FC236}">
                  <a16:creationId xmlns:a16="http://schemas.microsoft.com/office/drawing/2014/main" id="{F3D28264-3EF7-92F3-5819-6065E5E2F7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0176" y="5012199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8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2" name="Rectangle 26">
              <a:extLst>
                <a:ext uri="{FF2B5EF4-FFF2-40B4-BE49-F238E27FC236}">
                  <a16:creationId xmlns:a16="http://schemas.microsoft.com/office/drawing/2014/main" id="{1A049A26-8918-A358-A5AC-E09796C98D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2731" y="5012199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7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E98AD997-335F-6388-5960-56BCE8BAB2B8}"/>
                </a:ext>
              </a:extLst>
            </p:cNvPr>
            <p:cNvSpPr txBox="1"/>
            <p:nvPr/>
          </p:nvSpPr>
          <p:spPr>
            <a:xfrm>
              <a:off x="2473436" y="4574297"/>
              <a:ext cx="21311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Observation period (months)</a:t>
              </a:r>
              <a:endParaRPr kumimoji="1" lang="ja-JP" altLang="en-US" sz="12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4" name="Rectangle 26">
              <a:extLst>
                <a:ext uri="{FF2B5EF4-FFF2-40B4-BE49-F238E27FC236}">
                  <a16:creationId xmlns:a16="http://schemas.microsoft.com/office/drawing/2014/main" id="{456DD8B3-6551-D851-B8FB-EA47FE3DFC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1022" y="5012199"/>
              <a:ext cx="14542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1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5" name="Rectangle 26">
              <a:extLst>
                <a:ext uri="{FF2B5EF4-FFF2-40B4-BE49-F238E27FC236}">
                  <a16:creationId xmlns:a16="http://schemas.microsoft.com/office/drawing/2014/main" id="{D6AEC7C8-9DCA-B4F6-907E-F6EFA4ECFD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8199" y="5012199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7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6" name="Rectangle 26">
              <a:extLst>
                <a:ext uri="{FF2B5EF4-FFF2-40B4-BE49-F238E27FC236}">
                  <a16:creationId xmlns:a16="http://schemas.microsoft.com/office/drawing/2014/main" id="{4243ACAC-DA92-ED3C-5F90-0605FEFA3F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7779" y="5012199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6</a:t>
              </a:r>
              <a:endParaRPr kumimoji="1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7" name="Line 14">
              <a:extLst>
                <a:ext uri="{FF2B5EF4-FFF2-40B4-BE49-F238E27FC236}">
                  <a16:creationId xmlns:a16="http://schemas.microsoft.com/office/drawing/2014/main" id="{E58FDA2B-3A31-CC01-D9AA-50B8B49DB3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26080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Rectangle 24">
              <a:extLst>
                <a:ext uri="{FF2B5EF4-FFF2-40B4-BE49-F238E27FC236}">
                  <a16:creationId xmlns:a16="http://schemas.microsoft.com/office/drawing/2014/main" id="{1A9C3747-2477-239D-C3F4-400B590577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60410" y="4411074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14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89" name="Line 14">
              <a:extLst>
                <a:ext uri="{FF2B5EF4-FFF2-40B4-BE49-F238E27FC236}">
                  <a16:creationId xmlns:a16="http://schemas.microsoft.com/office/drawing/2014/main" id="{C3B2CF06-BB24-A868-9340-870421E736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73434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Rectangle 24">
              <a:extLst>
                <a:ext uri="{FF2B5EF4-FFF2-40B4-BE49-F238E27FC236}">
                  <a16:creationId xmlns:a16="http://schemas.microsoft.com/office/drawing/2014/main" id="{A291ABD0-0E13-EB76-7B84-56A2437728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03252" y="4411074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16</a:t>
              </a:r>
              <a:endParaRPr kumimoji="1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91" name="Line 14">
              <a:extLst>
                <a:ext uri="{FF2B5EF4-FFF2-40B4-BE49-F238E27FC236}">
                  <a16:creationId xmlns:a16="http://schemas.microsoft.com/office/drawing/2014/main" id="{ABD524F4-7F53-3873-4439-A88DE237EB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20789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Rectangle 24">
              <a:extLst>
                <a:ext uri="{FF2B5EF4-FFF2-40B4-BE49-F238E27FC236}">
                  <a16:creationId xmlns:a16="http://schemas.microsoft.com/office/drawing/2014/main" id="{D99F5204-3FF8-497B-E7C1-5BF6DE90B6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2908" y="4411074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18</a:t>
              </a:r>
              <a:endParaRPr kumimoji="1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93" name="Line 14">
              <a:extLst>
                <a:ext uri="{FF2B5EF4-FFF2-40B4-BE49-F238E27FC236}">
                  <a16:creationId xmlns:a16="http://schemas.microsoft.com/office/drawing/2014/main" id="{8B0D69A4-82B0-C030-01C1-F51C52C6D6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68139" y="4275373"/>
              <a:ext cx="0" cy="97542"/>
            </a:xfrm>
            <a:prstGeom prst="line">
              <a:avLst/>
            </a:pr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Rectangle 24">
              <a:extLst>
                <a:ext uri="{FF2B5EF4-FFF2-40B4-BE49-F238E27FC236}">
                  <a16:creationId xmlns:a16="http://schemas.microsoft.com/office/drawing/2014/main" id="{A8861FCA-2FBD-DEE9-34BB-FC0D2894BC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3653" y="4411074"/>
              <a:ext cx="135235" cy="1665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20</a:t>
              </a:r>
              <a:endParaRPr kumimoji="1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95" name="Rectangle 26">
              <a:extLst>
                <a:ext uri="{FF2B5EF4-FFF2-40B4-BE49-F238E27FC236}">
                  <a16:creationId xmlns:a16="http://schemas.microsoft.com/office/drawing/2014/main" id="{DC9AAA55-784B-5663-973D-D07DBB3791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3343" y="5012199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5</a:t>
              </a:r>
              <a:endParaRPr kumimoji="1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6" name="Rectangle 26">
              <a:extLst>
                <a:ext uri="{FF2B5EF4-FFF2-40B4-BE49-F238E27FC236}">
                  <a16:creationId xmlns:a16="http://schemas.microsoft.com/office/drawing/2014/main" id="{E3918AF1-8EC6-4265-55D2-8DD80CB8A9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3737" y="5012199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7" name="Rectangle 26">
              <a:extLst>
                <a:ext uri="{FF2B5EF4-FFF2-40B4-BE49-F238E27FC236}">
                  <a16:creationId xmlns:a16="http://schemas.microsoft.com/office/drawing/2014/main" id="{B1AAA5DF-573E-82E0-F6F4-3BF2507BA6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3774" y="5012199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kumimoji="1" lang="ja-JP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8" name="Rectangle 26">
              <a:extLst>
                <a:ext uri="{FF2B5EF4-FFF2-40B4-BE49-F238E27FC236}">
                  <a16:creationId xmlns:a16="http://schemas.microsoft.com/office/drawing/2014/main" id="{BE9541A2-02A7-9C53-78DD-D8D87B83C5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614" y="523599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3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9" name="Rectangle 26">
              <a:extLst>
                <a:ext uri="{FF2B5EF4-FFF2-40B4-BE49-F238E27FC236}">
                  <a16:creationId xmlns:a16="http://schemas.microsoft.com/office/drawing/2014/main" id="{BEAC1DC4-3BC9-C9FA-9EC0-F6C477278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1432" y="523599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6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00" name="Rectangle 26">
              <a:extLst>
                <a:ext uri="{FF2B5EF4-FFF2-40B4-BE49-F238E27FC236}">
                  <a16:creationId xmlns:a16="http://schemas.microsoft.com/office/drawing/2014/main" id="{AEA7BA43-BFC3-B00D-983A-83150F3D05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8303" y="523599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01" name="Rectangle 71">
              <a:extLst>
                <a:ext uri="{FF2B5EF4-FFF2-40B4-BE49-F238E27FC236}">
                  <a16:creationId xmlns:a16="http://schemas.microsoft.com/office/drawing/2014/main" id="{28233893-CB89-E556-11CF-87A5E7EF06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078" y="5012199"/>
              <a:ext cx="92813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/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plus </a:t>
              </a:r>
              <a:r>
                <a:rPr lang="en-US" altLang="ja-JP" sz="1200" b="1" dirty="0" err="1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Δlympho</a:t>
              </a:r>
              <a:endParaRPr kumimoji="1" lang="ja-JP" altLang="ja-JP" sz="1200" b="1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202" name="Rectangle 76">
              <a:extLst>
                <a:ext uri="{FF2B5EF4-FFF2-40B4-BE49-F238E27FC236}">
                  <a16:creationId xmlns:a16="http://schemas.microsoft.com/office/drawing/2014/main" id="{CE5D1D3C-75B2-9D5C-E536-098AD22915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881" y="5235993"/>
              <a:ext cx="102226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/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minus </a:t>
              </a:r>
              <a:r>
                <a:rPr lang="en-US" altLang="ja-JP" sz="1200" b="1" dirty="0" err="1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Δlympho</a:t>
              </a:r>
              <a:endParaRPr kumimoji="1" lang="ja-JP" altLang="ja-JP" sz="1200" b="1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EA5182E-A023-6984-97A4-A9C0DB8374DC}"/>
                </a:ext>
              </a:extLst>
            </p:cNvPr>
            <p:cNvSpPr txBox="1"/>
            <p:nvPr/>
          </p:nvSpPr>
          <p:spPr>
            <a:xfrm>
              <a:off x="2838894" y="607313"/>
              <a:ext cx="2481631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m</a:t>
              </a:r>
              <a:r>
                <a:rPr kumimoji="1"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edian </a:t>
              </a:r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PF</a:t>
              </a:r>
              <a:r>
                <a:rPr kumimoji="1"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S; months (95% CI)</a:t>
              </a:r>
            </a:p>
            <a:p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plus </a:t>
              </a:r>
              <a:r>
                <a:rPr lang="en-US" altLang="ja-JP" sz="1200" b="1" dirty="0" err="1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Δlympho</a:t>
              </a:r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; 7.07 (0.00</a:t>
              </a:r>
              <a:r>
                <a:rPr lang="en-US" altLang="ja-JP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–</a:t>
              </a:r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8.20)</a:t>
              </a:r>
            </a:p>
            <a:p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minus </a:t>
              </a:r>
              <a:r>
                <a:rPr lang="en-US" altLang="ja-JP" sz="1200" b="1" dirty="0" err="1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Δlympho</a:t>
              </a:r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;</a:t>
              </a:r>
              <a:r>
                <a:rPr lang="ja-JP" altLang="en-US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 </a:t>
              </a:r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.96 (0.94</a:t>
              </a:r>
              <a:r>
                <a:rPr lang="en-US" altLang="ja-JP" sz="1200" b="1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–</a:t>
              </a:r>
              <a:r>
                <a:rPr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.98)</a:t>
              </a:r>
            </a:p>
            <a:p>
              <a:r>
                <a:rPr kumimoji="1"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(log-rank </a:t>
              </a:r>
              <a:r>
                <a:rPr kumimoji="1" lang="en-US" altLang="ja-JP" sz="1200" b="1" i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p </a:t>
              </a:r>
              <a:r>
                <a:rPr kumimoji="1" lang="en-US" altLang="ja-JP" sz="1200" b="1" dirty="0"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= 0.032)</a:t>
              </a:r>
            </a:p>
          </p:txBody>
        </p: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317CCACD-DD54-C43B-7C3C-7B1D03755F9D}"/>
                </a:ext>
              </a:extLst>
            </p:cNvPr>
            <p:cNvCxnSpPr>
              <a:cxnSpLocks/>
            </p:cNvCxnSpPr>
            <p:nvPr/>
          </p:nvCxnSpPr>
          <p:spPr>
            <a:xfrm>
              <a:off x="2365366" y="1134331"/>
              <a:ext cx="473528" cy="0"/>
            </a:xfrm>
            <a:prstGeom prst="line">
              <a:avLst/>
            </a:prstGeom>
            <a:ln w="19050">
              <a:solidFill>
                <a:schemeClr val="accent6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E34E1266-7B71-364A-1D6A-F154115F3AF0}"/>
                </a:ext>
              </a:extLst>
            </p:cNvPr>
            <p:cNvCxnSpPr>
              <a:cxnSpLocks/>
            </p:cNvCxnSpPr>
            <p:nvPr/>
          </p:nvCxnSpPr>
          <p:spPr>
            <a:xfrm>
              <a:off x="2365366" y="938389"/>
              <a:ext cx="473528" cy="0"/>
            </a:xfrm>
            <a:prstGeom prst="line">
              <a:avLst/>
            </a:prstGeom>
            <a:ln w="19050">
              <a:solidFill>
                <a:srgbClr val="66003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4" name="Rectangle 26">
              <a:extLst>
                <a:ext uri="{FF2B5EF4-FFF2-40B4-BE49-F238E27FC236}">
                  <a16:creationId xmlns:a16="http://schemas.microsoft.com/office/drawing/2014/main" id="{BEAC1DC4-3BC9-C9FA-9EC0-F6C477278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6118" y="523599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2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55" name="Rectangle 26">
              <a:extLst>
                <a:ext uri="{FF2B5EF4-FFF2-40B4-BE49-F238E27FC236}">
                  <a16:creationId xmlns:a16="http://schemas.microsoft.com/office/drawing/2014/main" id="{AEA7BA43-BFC3-B00D-983A-83150F3D05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627" y="523599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56" name="Rectangle 26">
              <a:extLst>
                <a:ext uri="{FF2B5EF4-FFF2-40B4-BE49-F238E27FC236}">
                  <a16:creationId xmlns:a16="http://schemas.microsoft.com/office/drawing/2014/main" id="{BEAC1DC4-3BC9-C9FA-9EC0-F6C477278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3523" y="523599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57" name="Rectangle 26">
              <a:extLst>
                <a:ext uri="{FF2B5EF4-FFF2-40B4-BE49-F238E27FC236}">
                  <a16:creationId xmlns:a16="http://schemas.microsoft.com/office/drawing/2014/main" id="{AEA7BA43-BFC3-B00D-983A-83150F3D05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9044" y="523599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385" name="グループ化 384"/>
            <p:cNvGrpSpPr/>
            <p:nvPr/>
          </p:nvGrpSpPr>
          <p:grpSpPr>
            <a:xfrm>
              <a:off x="1287194" y="912128"/>
              <a:ext cx="4343862" cy="3002203"/>
              <a:chOff x="1287194" y="912128"/>
              <a:chExt cx="4343862" cy="3002203"/>
            </a:xfrm>
          </p:grpSpPr>
          <p:sp>
            <p:nvSpPr>
              <p:cNvPr id="386" name="Freeform 50"/>
              <p:cNvSpPr>
                <a:spLocks/>
              </p:cNvSpPr>
              <p:nvPr/>
            </p:nvSpPr>
            <p:spPr bwMode="auto">
              <a:xfrm>
                <a:off x="1287194" y="912128"/>
                <a:ext cx="3530520" cy="2972009"/>
              </a:xfrm>
              <a:custGeom>
                <a:avLst/>
                <a:gdLst>
                  <a:gd name="T0" fmla="*/ 0 w 2535"/>
                  <a:gd name="T1" fmla="*/ 0 h 2067"/>
                  <a:gd name="T2" fmla="*/ 126 w 2535"/>
                  <a:gd name="T3" fmla="*/ 0 h 2067"/>
                  <a:gd name="T4" fmla="*/ 126 w 2535"/>
                  <a:gd name="T5" fmla="*/ 175 h 2067"/>
                  <a:gd name="T6" fmla="*/ 138 w 2535"/>
                  <a:gd name="T7" fmla="*/ 175 h 2067"/>
                  <a:gd name="T8" fmla="*/ 138 w 2535"/>
                  <a:gd name="T9" fmla="*/ 350 h 2067"/>
                  <a:gd name="T10" fmla="*/ 201 w 2535"/>
                  <a:gd name="T11" fmla="*/ 350 h 2067"/>
                  <a:gd name="T12" fmla="*/ 201 w 2535"/>
                  <a:gd name="T13" fmla="*/ 525 h 2067"/>
                  <a:gd name="T14" fmla="*/ 236 w 2535"/>
                  <a:gd name="T15" fmla="*/ 525 h 2067"/>
                  <a:gd name="T16" fmla="*/ 236 w 2535"/>
                  <a:gd name="T17" fmla="*/ 700 h 2067"/>
                  <a:gd name="T18" fmla="*/ 259 w 2535"/>
                  <a:gd name="T19" fmla="*/ 700 h 2067"/>
                  <a:gd name="T20" fmla="*/ 259 w 2535"/>
                  <a:gd name="T21" fmla="*/ 876 h 2067"/>
                  <a:gd name="T22" fmla="*/ 276 w 2535"/>
                  <a:gd name="T23" fmla="*/ 876 h 2067"/>
                  <a:gd name="T24" fmla="*/ 276 w 2535"/>
                  <a:gd name="T25" fmla="*/ 1051 h 2067"/>
                  <a:gd name="T26" fmla="*/ 316 w 2535"/>
                  <a:gd name="T27" fmla="*/ 1051 h 2067"/>
                  <a:gd name="T28" fmla="*/ 316 w 2535"/>
                  <a:gd name="T29" fmla="*/ 1226 h 2067"/>
                  <a:gd name="T30" fmla="*/ 408 w 2535"/>
                  <a:gd name="T31" fmla="*/ 1226 h 2067"/>
                  <a:gd name="T32" fmla="*/ 408 w 2535"/>
                  <a:gd name="T33" fmla="*/ 1436 h 2067"/>
                  <a:gd name="T34" fmla="*/ 563 w 2535"/>
                  <a:gd name="T35" fmla="*/ 1436 h 2067"/>
                  <a:gd name="T36" fmla="*/ 563 w 2535"/>
                  <a:gd name="T37" fmla="*/ 1646 h 2067"/>
                  <a:gd name="T38" fmla="*/ 604 w 2535"/>
                  <a:gd name="T39" fmla="*/ 1646 h 2067"/>
                  <a:gd name="T40" fmla="*/ 604 w 2535"/>
                  <a:gd name="T41" fmla="*/ 1856 h 2067"/>
                  <a:gd name="T42" fmla="*/ 1190 w 2535"/>
                  <a:gd name="T43" fmla="*/ 1856 h 2067"/>
                  <a:gd name="T44" fmla="*/ 1190 w 2535"/>
                  <a:gd name="T45" fmla="*/ 2067 h 2067"/>
                  <a:gd name="T46" fmla="*/ 2535 w 2535"/>
                  <a:gd name="T47" fmla="*/ 2067 h 2067"/>
                  <a:gd name="T48" fmla="*/ 2535 w 2535"/>
                  <a:gd name="T49" fmla="*/ 2067 h 20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2535" h="2067">
                    <a:moveTo>
                      <a:pt x="0" y="0"/>
                    </a:moveTo>
                    <a:lnTo>
                      <a:pt x="126" y="0"/>
                    </a:lnTo>
                    <a:lnTo>
                      <a:pt x="126" y="175"/>
                    </a:lnTo>
                    <a:lnTo>
                      <a:pt x="138" y="175"/>
                    </a:lnTo>
                    <a:lnTo>
                      <a:pt x="138" y="350"/>
                    </a:lnTo>
                    <a:lnTo>
                      <a:pt x="201" y="350"/>
                    </a:lnTo>
                    <a:lnTo>
                      <a:pt x="201" y="525"/>
                    </a:lnTo>
                    <a:lnTo>
                      <a:pt x="236" y="525"/>
                    </a:lnTo>
                    <a:lnTo>
                      <a:pt x="236" y="700"/>
                    </a:lnTo>
                    <a:lnTo>
                      <a:pt x="259" y="700"/>
                    </a:lnTo>
                    <a:lnTo>
                      <a:pt x="259" y="876"/>
                    </a:lnTo>
                    <a:lnTo>
                      <a:pt x="276" y="876"/>
                    </a:lnTo>
                    <a:lnTo>
                      <a:pt x="276" y="1051"/>
                    </a:lnTo>
                    <a:lnTo>
                      <a:pt x="316" y="1051"/>
                    </a:lnTo>
                    <a:lnTo>
                      <a:pt x="316" y="1226"/>
                    </a:lnTo>
                    <a:lnTo>
                      <a:pt x="408" y="1226"/>
                    </a:lnTo>
                    <a:lnTo>
                      <a:pt x="408" y="1436"/>
                    </a:lnTo>
                    <a:lnTo>
                      <a:pt x="563" y="1436"/>
                    </a:lnTo>
                    <a:lnTo>
                      <a:pt x="563" y="1646"/>
                    </a:lnTo>
                    <a:lnTo>
                      <a:pt x="604" y="1646"/>
                    </a:lnTo>
                    <a:lnTo>
                      <a:pt x="604" y="1856"/>
                    </a:lnTo>
                    <a:lnTo>
                      <a:pt x="1190" y="1856"/>
                    </a:lnTo>
                    <a:lnTo>
                      <a:pt x="1190" y="2067"/>
                    </a:lnTo>
                    <a:lnTo>
                      <a:pt x="2535" y="2067"/>
                    </a:lnTo>
                    <a:lnTo>
                      <a:pt x="2535" y="2067"/>
                    </a:lnTo>
                  </a:path>
                </a:pathLst>
              </a:custGeom>
              <a:noFill/>
              <a:ln w="19050" cap="flat">
                <a:solidFill>
                  <a:schemeClr val="accent6">
                    <a:lumMod val="50000"/>
                  </a:schemeClr>
                </a:solidFill>
                <a:prstDash val="sysDash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7" name="Freeform 51"/>
              <p:cNvSpPr>
                <a:spLocks/>
              </p:cNvSpPr>
              <p:nvPr/>
            </p:nvSpPr>
            <p:spPr bwMode="auto">
              <a:xfrm>
                <a:off x="1287194" y="912128"/>
                <a:ext cx="4314615" cy="2414129"/>
              </a:xfrm>
              <a:custGeom>
                <a:avLst/>
                <a:gdLst>
                  <a:gd name="T0" fmla="*/ 0 w 3098"/>
                  <a:gd name="T1" fmla="*/ 0 h 1679"/>
                  <a:gd name="T2" fmla="*/ 126 w 3098"/>
                  <a:gd name="T3" fmla="*/ 0 h 1679"/>
                  <a:gd name="T4" fmla="*/ 126 w 3098"/>
                  <a:gd name="T5" fmla="*/ 134 h 1679"/>
                  <a:gd name="T6" fmla="*/ 155 w 3098"/>
                  <a:gd name="T7" fmla="*/ 134 h 1679"/>
                  <a:gd name="T8" fmla="*/ 155 w 3098"/>
                  <a:gd name="T9" fmla="*/ 267 h 1679"/>
                  <a:gd name="T10" fmla="*/ 241 w 3098"/>
                  <a:gd name="T11" fmla="*/ 267 h 1679"/>
                  <a:gd name="T12" fmla="*/ 241 w 3098"/>
                  <a:gd name="T13" fmla="*/ 411 h 1679"/>
                  <a:gd name="T14" fmla="*/ 443 w 3098"/>
                  <a:gd name="T15" fmla="*/ 411 h 1679"/>
                  <a:gd name="T16" fmla="*/ 443 w 3098"/>
                  <a:gd name="T17" fmla="*/ 555 h 1679"/>
                  <a:gd name="T18" fmla="*/ 489 w 3098"/>
                  <a:gd name="T19" fmla="*/ 555 h 1679"/>
                  <a:gd name="T20" fmla="*/ 489 w 3098"/>
                  <a:gd name="T21" fmla="*/ 698 h 1679"/>
                  <a:gd name="T22" fmla="*/ 673 w 3098"/>
                  <a:gd name="T23" fmla="*/ 698 h 1679"/>
                  <a:gd name="T24" fmla="*/ 673 w 3098"/>
                  <a:gd name="T25" fmla="*/ 842 h 1679"/>
                  <a:gd name="T26" fmla="*/ 816 w 3098"/>
                  <a:gd name="T27" fmla="*/ 842 h 1679"/>
                  <a:gd name="T28" fmla="*/ 816 w 3098"/>
                  <a:gd name="T29" fmla="*/ 1001 h 1679"/>
                  <a:gd name="T30" fmla="*/ 1138 w 3098"/>
                  <a:gd name="T31" fmla="*/ 1001 h 1679"/>
                  <a:gd name="T32" fmla="*/ 1138 w 3098"/>
                  <a:gd name="T33" fmla="*/ 1161 h 1679"/>
                  <a:gd name="T34" fmla="*/ 1816 w 3098"/>
                  <a:gd name="T35" fmla="*/ 1161 h 1679"/>
                  <a:gd name="T36" fmla="*/ 1816 w 3098"/>
                  <a:gd name="T37" fmla="*/ 1320 h 1679"/>
                  <a:gd name="T38" fmla="*/ 2081 w 3098"/>
                  <a:gd name="T39" fmla="*/ 1320 h 1679"/>
                  <a:gd name="T40" fmla="*/ 2081 w 3098"/>
                  <a:gd name="T41" fmla="*/ 1480 h 1679"/>
                  <a:gd name="T42" fmla="*/ 2339 w 3098"/>
                  <a:gd name="T43" fmla="*/ 1480 h 1679"/>
                  <a:gd name="T44" fmla="*/ 2339 w 3098"/>
                  <a:gd name="T45" fmla="*/ 1679 h 1679"/>
                  <a:gd name="T46" fmla="*/ 3098 w 3098"/>
                  <a:gd name="T47" fmla="*/ 1679 h 1679"/>
                  <a:gd name="T48" fmla="*/ 3098 w 3098"/>
                  <a:gd name="T49" fmla="*/ 1679 h 16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3098" h="1679">
                    <a:moveTo>
                      <a:pt x="0" y="0"/>
                    </a:moveTo>
                    <a:lnTo>
                      <a:pt x="126" y="0"/>
                    </a:lnTo>
                    <a:lnTo>
                      <a:pt x="126" y="134"/>
                    </a:lnTo>
                    <a:lnTo>
                      <a:pt x="155" y="134"/>
                    </a:lnTo>
                    <a:lnTo>
                      <a:pt x="155" y="267"/>
                    </a:lnTo>
                    <a:lnTo>
                      <a:pt x="241" y="267"/>
                    </a:lnTo>
                    <a:lnTo>
                      <a:pt x="241" y="411"/>
                    </a:lnTo>
                    <a:lnTo>
                      <a:pt x="443" y="411"/>
                    </a:lnTo>
                    <a:lnTo>
                      <a:pt x="443" y="555"/>
                    </a:lnTo>
                    <a:lnTo>
                      <a:pt x="489" y="555"/>
                    </a:lnTo>
                    <a:lnTo>
                      <a:pt x="489" y="698"/>
                    </a:lnTo>
                    <a:lnTo>
                      <a:pt x="673" y="698"/>
                    </a:lnTo>
                    <a:lnTo>
                      <a:pt x="673" y="842"/>
                    </a:lnTo>
                    <a:lnTo>
                      <a:pt x="816" y="842"/>
                    </a:lnTo>
                    <a:lnTo>
                      <a:pt x="816" y="1001"/>
                    </a:lnTo>
                    <a:lnTo>
                      <a:pt x="1138" y="1001"/>
                    </a:lnTo>
                    <a:lnTo>
                      <a:pt x="1138" y="1161"/>
                    </a:lnTo>
                    <a:lnTo>
                      <a:pt x="1816" y="1161"/>
                    </a:lnTo>
                    <a:lnTo>
                      <a:pt x="1816" y="1320"/>
                    </a:lnTo>
                    <a:lnTo>
                      <a:pt x="2081" y="1320"/>
                    </a:lnTo>
                    <a:lnTo>
                      <a:pt x="2081" y="1480"/>
                    </a:lnTo>
                    <a:lnTo>
                      <a:pt x="2339" y="1480"/>
                    </a:lnTo>
                    <a:lnTo>
                      <a:pt x="2339" y="1679"/>
                    </a:lnTo>
                    <a:lnTo>
                      <a:pt x="3098" y="1679"/>
                    </a:lnTo>
                    <a:lnTo>
                      <a:pt x="3098" y="1679"/>
                    </a:lnTo>
                  </a:path>
                </a:pathLst>
              </a:custGeom>
              <a:noFill/>
              <a:ln w="19050" cap="flat">
                <a:solidFill>
                  <a:srgbClr val="660033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8" name="Freeform 52"/>
              <p:cNvSpPr>
                <a:spLocks noEditPoints="1"/>
              </p:cNvSpPr>
              <p:nvPr/>
            </p:nvSpPr>
            <p:spPr bwMode="auto">
              <a:xfrm>
                <a:off x="1770464" y="2644722"/>
                <a:ext cx="58494" cy="60389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9" name="Freeform 53"/>
              <p:cNvSpPr>
                <a:spLocks noEditPoints="1"/>
              </p:cNvSpPr>
              <p:nvPr/>
            </p:nvSpPr>
            <p:spPr bwMode="auto">
              <a:xfrm>
                <a:off x="4788467" y="3853942"/>
                <a:ext cx="58494" cy="60389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chemeClr val="accent6">
                    <a:lumMod val="50000"/>
                  </a:schemeClr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0" name="Freeform 54"/>
              <p:cNvSpPr>
                <a:spLocks noEditPoints="1"/>
              </p:cNvSpPr>
              <p:nvPr/>
            </p:nvSpPr>
            <p:spPr bwMode="auto">
              <a:xfrm>
                <a:off x="1554594" y="1267274"/>
                <a:ext cx="58494" cy="60389"/>
              </a:xfrm>
              <a:custGeom>
                <a:avLst/>
                <a:gdLst>
                  <a:gd name="T0" fmla="*/ 0 w 42"/>
                  <a:gd name="T1" fmla="*/ 20 h 42"/>
                  <a:gd name="T2" fmla="*/ 42 w 42"/>
                  <a:gd name="T3" fmla="*/ 20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0"/>
                    </a:moveTo>
                    <a:lnTo>
                      <a:pt x="42" y="20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1" name="Freeform 55"/>
              <p:cNvSpPr>
                <a:spLocks noEditPoints="1"/>
              </p:cNvSpPr>
              <p:nvPr/>
            </p:nvSpPr>
            <p:spPr bwMode="auto">
              <a:xfrm>
                <a:off x="2323370" y="2092592"/>
                <a:ext cx="58494" cy="60389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0 w 42"/>
                  <a:gd name="T5" fmla="*/ 0 h 42"/>
                  <a:gd name="T6" fmla="*/ 20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0" y="0"/>
                    </a:moveTo>
                    <a:lnTo>
                      <a:pt x="20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2" name="Freeform 56"/>
              <p:cNvSpPr>
                <a:spLocks noEditPoints="1"/>
              </p:cNvSpPr>
              <p:nvPr/>
            </p:nvSpPr>
            <p:spPr bwMode="auto">
              <a:xfrm>
                <a:off x="4404079" y="3009932"/>
                <a:ext cx="58494" cy="58952"/>
              </a:xfrm>
              <a:custGeom>
                <a:avLst/>
                <a:gdLst>
                  <a:gd name="T0" fmla="*/ 0 w 42"/>
                  <a:gd name="T1" fmla="*/ 21 h 41"/>
                  <a:gd name="T2" fmla="*/ 42 w 42"/>
                  <a:gd name="T3" fmla="*/ 21 h 41"/>
                  <a:gd name="T4" fmla="*/ 21 w 42"/>
                  <a:gd name="T5" fmla="*/ 0 h 41"/>
                  <a:gd name="T6" fmla="*/ 21 w 42"/>
                  <a:gd name="T7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1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1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3" name="Freeform 57"/>
              <p:cNvSpPr>
                <a:spLocks noEditPoints="1"/>
              </p:cNvSpPr>
              <p:nvPr/>
            </p:nvSpPr>
            <p:spPr bwMode="auto">
              <a:xfrm>
                <a:off x="4844175" y="3296062"/>
                <a:ext cx="58494" cy="60389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4" name="Freeform 58"/>
              <p:cNvSpPr>
                <a:spLocks noEditPoints="1"/>
              </p:cNvSpPr>
              <p:nvPr/>
            </p:nvSpPr>
            <p:spPr bwMode="auto">
              <a:xfrm>
                <a:off x="5484822" y="3296062"/>
                <a:ext cx="57102" cy="60389"/>
              </a:xfrm>
              <a:custGeom>
                <a:avLst/>
                <a:gdLst>
                  <a:gd name="T0" fmla="*/ 0 w 41"/>
                  <a:gd name="T1" fmla="*/ 21 h 42"/>
                  <a:gd name="T2" fmla="*/ 41 w 41"/>
                  <a:gd name="T3" fmla="*/ 21 h 42"/>
                  <a:gd name="T4" fmla="*/ 21 w 41"/>
                  <a:gd name="T5" fmla="*/ 0 h 42"/>
                  <a:gd name="T6" fmla="*/ 21 w 41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1" h="42">
                    <a:moveTo>
                      <a:pt x="0" y="21"/>
                    </a:moveTo>
                    <a:lnTo>
                      <a:pt x="41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5" name="Freeform 59"/>
              <p:cNvSpPr>
                <a:spLocks noEditPoints="1"/>
              </p:cNvSpPr>
              <p:nvPr/>
            </p:nvSpPr>
            <p:spPr bwMode="auto">
              <a:xfrm>
                <a:off x="5572562" y="3296062"/>
                <a:ext cx="58494" cy="60389"/>
              </a:xfrm>
              <a:custGeom>
                <a:avLst/>
                <a:gdLst>
                  <a:gd name="T0" fmla="*/ 0 w 42"/>
                  <a:gd name="T1" fmla="*/ 21 h 42"/>
                  <a:gd name="T2" fmla="*/ 42 w 42"/>
                  <a:gd name="T3" fmla="*/ 21 h 42"/>
                  <a:gd name="T4" fmla="*/ 21 w 42"/>
                  <a:gd name="T5" fmla="*/ 0 h 42"/>
                  <a:gd name="T6" fmla="*/ 21 w 42"/>
                  <a:gd name="T7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2" h="42">
                    <a:moveTo>
                      <a:pt x="0" y="21"/>
                    </a:moveTo>
                    <a:lnTo>
                      <a:pt x="42" y="21"/>
                    </a:lnTo>
                    <a:moveTo>
                      <a:pt x="21" y="0"/>
                    </a:moveTo>
                    <a:lnTo>
                      <a:pt x="21" y="42"/>
                    </a:lnTo>
                  </a:path>
                </a:pathLst>
              </a:custGeom>
              <a:noFill/>
              <a:ln w="19050" cap="rnd">
                <a:solidFill>
                  <a:srgbClr val="6600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396" name="Rectangle 26">
              <a:extLst>
                <a:ext uri="{FF2B5EF4-FFF2-40B4-BE49-F238E27FC236}">
                  <a16:creationId xmlns:a16="http://schemas.microsoft.com/office/drawing/2014/main" id="{AEA7BA43-BFC3-B00D-983A-83150F3D05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3354" y="5233125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游ゴシック" panose="020B0400000000000000" pitchFamily="50" charset="-128"/>
                  <a:cs typeface="Times New Roman" panose="02020603050405020304" pitchFamily="18" charset="0"/>
                </a:rPr>
                <a:t>1</a:t>
              </a:r>
              <a:endParaRPr kumimoji="1" lang="ja-JP" altLang="ja-JP" sz="2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19445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3</TotalTime>
  <Words>123</Words>
  <Application>Microsoft Office PowerPoint</Application>
  <PresentationFormat>ワイド画面</PresentationFormat>
  <Paragraphs>4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一 本間</dc:creator>
  <cp:lastModifiedBy>雄一 本間</cp:lastModifiedBy>
  <cp:revision>50</cp:revision>
  <dcterms:created xsi:type="dcterms:W3CDTF">2024-11-23T09:58:41Z</dcterms:created>
  <dcterms:modified xsi:type="dcterms:W3CDTF">2025-04-09T08:26:59Z</dcterms:modified>
</cp:coreProperties>
</file>